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462316-5F48-40CD-8482-EFDE45C1E2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055A54-7B0D-482E-B749-3966C08799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91970-0BA6-425A-9959-D2D1A784B9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C6305-288E-4A90-9973-65F523505A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74C0A-B43F-406F-9B78-94CB380B72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90859-0F74-4534-BF76-F0E4F9F878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939468-5223-4CC8-9951-BA620AAF42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2629C-A99A-40BB-BFC4-61B0D9CF7F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70D9A-60CE-4EE5-835E-FB8C173C97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1DAFEF-EB00-4AF3-B703-D315CF3D49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B3DBE-51F9-4DC8-8F74-8B8E54FDC3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F89C56-A3D0-46FA-B62E-8596169C9C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ED95B4-03DC-4FE4-8F63-ADC91894EFA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5508720" y="825480"/>
            <a:ext cx="3384360" cy="435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Figure S7. Overlapping PCR assays of plasmid encoding the variant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gene in four isolates using primers designed to amplify the pCPF5603/pCPPB-1 transfer region.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Shown are results obtained using DNA from strains (PB-1, 3441, TGII002 and TGII003), which carry the plasmid-borne variant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gene or from F4969 and F5603 which carrying the classical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cpe 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plasmids pCPF4969 and pCPF5603. Using primers previously described, the region assayed with PCR reaction (T6 to T16) contained the eight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tcp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tcpA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to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tcpI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) genes and the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intP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gene, which genes are thought to be necessary for plasmid transfer (Table S4) [11, 13]. The overlapping PCR (reaction T14t to T16t) used newly constructed primers based on the sequence information of the </a:t>
            </a:r>
            <a:r>
              <a:rPr b="0" i="1" lang="ja-JP" sz="1400" spc="-1" strike="noStrike">
                <a:solidFill>
                  <a:srgbClr val="000000"/>
                </a:solidFill>
                <a:latin typeface="Arial"/>
              </a:rPr>
              <a:t>tcpA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region on pCPPB-1 (Table S4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7" descr=""/>
          <p:cNvPicPr/>
          <p:nvPr/>
        </p:nvPicPr>
        <p:blipFill>
          <a:blip r:embed="rId1"/>
          <a:stretch/>
        </p:blipFill>
        <p:spPr>
          <a:xfrm>
            <a:off x="544680" y="379440"/>
            <a:ext cx="4964040" cy="6145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4T00:01:52Z</dcterms:created>
  <dc:creator>MIYAMOTO</dc:creator>
  <dc:description/>
  <dc:language>en-US</dc:language>
  <cp:lastModifiedBy>MIYAMOTO</cp:lastModifiedBy>
  <dcterms:modified xsi:type="dcterms:W3CDTF">2011-05-04T00:05:09Z</dcterms:modified>
  <cp:revision>7</cp:revision>
  <dc:subject/>
  <dc:title>スライド 1</dc:title>
</cp:coreProperties>
</file>